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>
        <p:scale>
          <a:sx n="100" d="100"/>
          <a:sy n="100" d="100"/>
        </p:scale>
        <p:origin x="389" y="-20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72CEB6-CB71-442B-85A9-6EB328C8C484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563C-40D9-415B-BFB0-4AFD234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675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72CEB6-CB71-442B-85A9-6EB328C8C484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563C-40D9-415B-BFB0-4AFD234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310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72CEB6-CB71-442B-85A9-6EB328C8C484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563C-40D9-415B-BFB0-4AFD234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836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72CEB6-CB71-442B-85A9-6EB328C8C484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563C-40D9-415B-BFB0-4AFD234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9313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72CEB6-CB71-442B-85A9-6EB328C8C484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563C-40D9-415B-BFB0-4AFD234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761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72CEB6-CB71-442B-85A9-6EB328C8C484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563C-40D9-415B-BFB0-4AFD234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297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72CEB6-CB71-442B-85A9-6EB328C8C484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563C-40D9-415B-BFB0-4AFD234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31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72CEB6-CB71-442B-85A9-6EB328C8C484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563C-40D9-415B-BFB0-4AFD234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4047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72CEB6-CB71-442B-85A9-6EB328C8C484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563C-40D9-415B-BFB0-4AFD234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4070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72CEB6-CB71-442B-85A9-6EB328C8C484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563C-40D9-415B-BFB0-4AFD234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990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72CEB6-CB71-442B-85A9-6EB328C8C484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F2563C-40D9-415B-BFB0-4AFD234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717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72CEB6-CB71-442B-85A9-6EB328C8C484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F2563C-40D9-415B-BFB0-4AFD23436B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834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21721" y="2646053"/>
            <a:ext cx="5838669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GYYDGPNLNEEHSETREVRKSGSKK</a:t>
            </a:r>
            <a:r>
              <a:rPr lang="en-US" sz="1200" dirty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YFFTGLVGAVVGAVSISFAA</a:t>
            </a:r>
            <a:r>
              <a:rPr lang="en-US" sz="1200" dirty="0"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YMPWAQNNGATVSSFSSDSKVEGTVVPV</a:t>
            </a:r>
            <a:r>
              <a:rPr lang="en-US" sz="1200" b="1" u="sng" dirty="0"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VNKAKNETDLPG</a:t>
            </a:r>
            <a:r>
              <a:rPr lang="en-US" sz="1200" b="1" dirty="0"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IEGAKDVVVGVINMQQSIDPFAMQPTGQEQQAGSGSGVIYKKAGNKAYIVTN</a:t>
            </a:r>
            <a:r>
              <a:rPr lang="en-US" sz="1200" b="1" dirty="0"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NHVV</a:t>
            </a:r>
            <a:r>
              <a:rPr lang="en-US" sz="1200" b="1" dirty="0"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DGANKLAVKLSDGKKVDAKLVGKDPW</a:t>
            </a:r>
            <a:r>
              <a:rPr lang="en-US" sz="1200" b="1" dirty="0"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DLAV</a:t>
            </a:r>
            <a:r>
              <a:rPr lang="en-US" sz="1200" b="1" dirty="0"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VEIDGANVNKVATLGDSSKIRAGEKAIAIGNPLGFDGSVTEGIISSKEREIPVDIDGDKRADWNAQVIQTDAAINP</a:t>
            </a:r>
            <a:r>
              <a:rPr lang="en-US" sz="1200" b="1" dirty="0">
                <a:solidFill>
                  <a:srgbClr val="00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NSGGAL</a:t>
            </a:r>
            <a:r>
              <a:rPr lang="en-US" sz="1200" b="1" dirty="0"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FNQNGEIIGINSSKIAQQEVEGIGFAIPINIAKPVIESLEKDGVVKRPALGVGVVSLEDVQAYAVNQLKVPKEVTNGVVLGKIYPISPAEKAGLEQYDIVVALDNQKVENSLQFRKYLYEKKKVGEKVEVTFYRNGQKMTKTATLADNSATKNQ</a:t>
            </a:r>
            <a:r>
              <a:rPr lang="en-US" sz="1200" b="1" dirty="0"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200" dirty="0">
              <a:effectLst/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1200" b="1" dirty="0"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endParaRPr lang="en-US" sz="1200" b="1" dirty="0"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2 Fig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mino acid sequence of </a:t>
            </a:r>
            <a:r>
              <a:rPr lang="en-US" sz="12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rA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rotease. </a:t>
            </a: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ansmembrane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omain identified by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Mpred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oftware (</a:t>
            </a:r>
            <a:r>
              <a:rPr lang="en-US" sz="1200" dirty="0">
                <a:solidFill>
                  <a:srgbClr val="0000FF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tp://www.ch.embnet.org/software/TMPRED_form.html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s indicated in red.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creted part of the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rA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s shown in bold, amino acids identified by N-terminal degradation method are underlined. Molecular mass is 43.9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the whole molecule, and 35.85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secreted form.</a:t>
            </a:r>
            <a:endParaRPr lang="en-US" sz="1200" dirty="0">
              <a:effectLst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887041" y="1909870"/>
            <a:ext cx="11972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2 Fig. </a:t>
            </a:r>
          </a:p>
        </p:txBody>
      </p:sp>
    </p:spTree>
    <p:extLst>
      <p:ext uri="{BB962C8B-B14F-4D97-AF65-F5344CB8AC3E}">
        <p14:creationId xmlns:p14="http://schemas.microsoft.com/office/powerpoint/2010/main" val="5722162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4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</vt:vector>
  </TitlesOfParts>
  <Company>NIH\NIAI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merantsev, Andrei (NIH/NIAID) [E]</dc:creator>
  <cp:lastModifiedBy>Pomerantsev, Andrei (NIH/NIAID) [E]</cp:lastModifiedBy>
  <cp:revision>11</cp:revision>
  <dcterms:created xsi:type="dcterms:W3CDTF">2016-12-01T20:08:34Z</dcterms:created>
  <dcterms:modified xsi:type="dcterms:W3CDTF">2017-05-11T15:02:47Z</dcterms:modified>
</cp:coreProperties>
</file>